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57" r:id="rId3"/>
    <p:sldId id="256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-876" y="-4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D52688-F8FB-4305-8FD7-C3C873349792}" type="datetimeFigureOut">
              <a:rPr lang="en-US" smtClean="0"/>
              <a:t>2021-12-16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8DB46E-BD88-43BF-85A9-69F2EB93B23A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4451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9692EFE9-8E51-47B6-9823-F86135C6F9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="" xmlns:a16="http://schemas.microsoft.com/office/drawing/2014/main" id="{581EAD5D-D23B-49C6-85A4-3F2CD0A748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E04A471B-11CB-4577-B18C-9455D0BBAF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18104-7529-4603-8183-3844D4C38BF7}" type="datetimeFigureOut">
              <a:rPr lang="fr-FR" smtClean="0"/>
              <a:t>16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4CF85359-C8F8-425B-8654-A619289078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9ABB417A-3458-46C7-A902-EE0B49C2DF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432D6-3426-44AA-A865-C115F9DCCA9A}" type="slidenum">
              <a:rPr lang="fr-FR" smtClean="0"/>
              <a:t>‹N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0641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1ADB7557-A227-4A8F-B4DE-A6C65F4DC2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="" xmlns:a16="http://schemas.microsoft.com/office/drawing/2014/main" id="{0DB6DFF8-740F-4BFA-AE0F-E4DF5A3FD5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924CFD83-81B3-40B0-9AD9-F5A652CC0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18104-7529-4603-8183-3844D4C38BF7}" type="datetimeFigureOut">
              <a:rPr lang="fr-FR" smtClean="0"/>
              <a:t>16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227C1DBA-B3B5-484A-BB42-655D64DA8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12D07A2B-46E5-43D0-9994-4CE6AA0FE0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432D6-3426-44AA-A865-C115F9DCCA9A}" type="slidenum">
              <a:rPr lang="fr-FR" smtClean="0"/>
              <a:t>‹N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7112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="" xmlns:a16="http://schemas.microsoft.com/office/drawing/2014/main" id="{DFBFB30B-5A88-4FC1-96FA-A51E876C2E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="" xmlns:a16="http://schemas.microsoft.com/office/drawing/2014/main" id="{3293094E-49BE-466E-ADEA-FC77BB87A4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246F21D8-8C93-4EF3-A1F1-94F56BF4A6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18104-7529-4603-8183-3844D4C38BF7}" type="datetimeFigureOut">
              <a:rPr lang="fr-FR" smtClean="0"/>
              <a:t>16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276E24BB-55EF-4356-8890-01FC33F8D0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71E0A3EC-B102-44CA-8BB4-DEAD59DBB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432D6-3426-44AA-A865-C115F9DCCA9A}" type="slidenum">
              <a:rPr lang="fr-FR" smtClean="0"/>
              <a:t>‹N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9545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8C669224-3A62-4A95-AF92-6ECCA6AC0E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="" xmlns:a16="http://schemas.microsoft.com/office/drawing/2014/main" id="{A8EC49BB-42AE-42A4-AD83-72CE6FDE2D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992E136E-0EA1-450D-940D-8D9F2492BF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18104-7529-4603-8183-3844D4C38BF7}" type="datetimeFigureOut">
              <a:rPr lang="fr-FR" smtClean="0"/>
              <a:t>16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AFA301B6-FF40-4839-866E-587879FEB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47648EAB-521D-439F-8D0A-A29A3DBAA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432D6-3426-44AA-A865-C115F9DCCA9A}" type="slidenum">
              <a:rPr lang="fr-FR" smtClean="0"/>
              <a:t>‹N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0352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751AC2DE-6B4B-4E57-8E25-D0D408333B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="" xmlns:a16="http://schemas.microsoft.com/office/drawing/2014/main" id="{534410CC-D62A-418F-8390-19F811DC03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3668BC0D-E441-4445-9A94-934059D92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18104-7529-4603-8183-3844D4C38BF7}" type="datetimeFigureOut">
              <a:rPr lang="fr-FR" smtClean="0"/>
              <a:t>16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D1299D82-D8D1-4232-A754-91B4F21B5F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64912A5A-7713-4D90-B2B8-4E72B79C4A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432D6-3426-44AA-A865-C115F9DCCA9A}" type="slidenum">
              <a:rPr lang="fr-FR" smtClean="0"/>
              <a:t>‹N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8799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2341B05D-F5EF-424B-8CE5-AF219227C6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="" xmlns:a16="http://schemas.microsoft.com/office/drawing/2014/main" id="{67AF2AAA-F2C3-4605-8817-322D6F2084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="" xmlns:a16="http://schemas.microsoft.com/office/drawing/2014/main" id="{E7733F04-E576-4ABA-B1FC-381D7495BF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="" xmlns:a16="http://schemas.microsoft.com/office/drawing/2014/main" id="{7F066FA7-F937-4645-A00B-E9603AC55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18104-7529-4603-8183-3844D4C38BF7}" type="datetimeFigureOut">
              <a:rPr lang="fr-FR" smtClean="0"/>
              <a:t>16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="" xmlns:a16="http://schemas.microsoft.com/office/drawing/2014/main" id="{A0CB7F58-9801-4217-AB02-0659DB8F04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="" xmlns:a16="http://schemas.microsoft.com/office/drawing/2014/main" id="{55D8F15A-1368-4120-8EA5-5AF03B7C08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432D6-3426-44AA-A865-C115F9DCCA9A}" type="slidenum">
              <a:rPr lang="fr-FR" smtClean="0"/>
              <a:t>‹N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9385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0896A145-1C1D-4479-BBF0-45F94D0D57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="" xmlns:a16="http://schemas.microsoft.com/office/drawing/2014/main" id="{2705E856-E377-4C4F-8E74-5B205EFD1C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="" xmlns:a16="http://schemas.microsoft.com/office/drawing/2014/main" id="{4E6D874C-6B8D-4A2D-B976-EC80DBC8A9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="" xmlns:a16="http://schemas.microsoft.com/office/drawing/2014/main" id="{0CD54A92-F1C7-4360-9341-5144CA9E9E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="" xmlns:a16="http://schemas.microsoft.com/office/drawing/2014/main" id="{6FE02C4D-09C0-4B2A-A05D-55EDBEC404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="" xmlns:a16="http://schemas.microsoft.com/office/drawing/2014/main" id="{9F8ABF25-F851-43E6-A6CB-7C65E873E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18104-7529-4603-8183-3844D4C38BF7}" type="datetimeFigureOut">
              <a:rPr lang="fr-FR" smtClean="0"/>
              <a:t>16/12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="" xmlns:a16="http://schemas.microsoft.com/office/drawing/2014/main" id="{B0635785-3A2D-4C0A-B9BF-ADF36FA13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="" xmlns:a16="http://schemas.microsoft.com/office/drawing/2014/main" id="{27F42DB3-D594-4738-B6CC-AB191B77F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432D6-3426-44AA-A865-C115F9DCCA9A}" type="slidenum">
              <a:rPr lang="fr-FR" smtClean="0"/>
              <a:t>‹N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8740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38F292A1-739B-4759-A4CA-54CCEE069C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="" xmlns:a16="http://schemas.microsoft.com/office/drawing/2014/main" id="{5891BE34-6B97-4CC6-A8F7-052DECFA8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18104-7529-4603-8183-3844D4C38BF7}" type="datetimeFigureOut">
              <a:rPr lang="fr-FR" smtClean="0"/>
              <a:t>16/12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="" xmlns:a16="http://schemas.microsoft.com/office/drawing/2014/main" id="{D08F3424-D321-4938-A75C-6D30D50A3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="" xmlns:a16="http://schemas.microsoft.com/office/drawing/2014/main" id="{A1B0E85B-C3EA-4CBF-A9C0-D55A9CE90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432D6-3426-44AA-A865-C115F9DCCA9A}" type="slidenum">
              <a:rPr lang="fr-FR" smtClean="0"/>
              <a:t>‹N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9762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="" xmlns:a16="http://schemas.microsoft.com/office/drawing/2014/main" id="{71C47AE0-2616-4361-B564-BD36D5696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18104-7529-4603-8183-3844D4C38BF7}" type="datetimeFigureOut">
              <a:rPr lang="fr-FR" smtClean="0"/>
              <a:t>16/12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="" xmlns:a16="http://schemas.microsoft.com/office/drawing/2014/main" id="{D1351C63-2196-4C99-85BB-9EC8ECA9D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="" xmlns:a16="http://schemas.microsoft.com/office/drawing/2014/main" id="{410ABF8F-42C3-4E8A-BEFF-6AC30FFBA7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432D6-3426-44AA-A865-C115F9DCCA9A}" type="slidenum">
              <a:rPr lang="fr-FR" smtClean="0"/>
              <a:t>‹N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0457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A43583C7-0F94-47F5-9E11-C36D482EE3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="" xmlns:a16="http://schemas.microsoft.com/office/drawing/2014/main" id="{5CCB82C9-EC3A-41CB-A733-DA6B45A148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="" xmlns:a16="http://schemas.microsoft.com/office/drawing/2014/main" id="{30479EC7-8FB7-4DA8-8C8E-78471CD3E2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="" xmlns:a16="http://schemas.microsoft.com/office/drawing/2014/main" id="{1AA96D7A-ECA9-40C6-80A1-A96479CA4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18104-7529-4603-8183-3844D4C38BF7}" type="datetimeFigureOut">
              <a:rPr lang="fr-FR" smtClean="0"/>
              <a:t>16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="" xmlns:a16="http://schemas.microsoft.com/office/drawing/2014/main" id="{3450CD8A-DE85-4E8D-B266-B1C91DAC8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="" xmlns:a16="http://schemas.microsoft.com/office/drawing/2014/main" id="{7B1FB16A-8A90-44AC-9702-6C1C003EC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432D6-3426-44AA-A865-C115F9DCCA9A}" type="slidenum">
              <a:rPr lang="fr-FR" smtClean="0"/>
              <a:t>‹N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6534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="" xmlns:a16="http://schemas.microsoft.com/office/drawing/2014/main" id="{008CD500-47B4-46E2-B4BD-FB93E313BE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="" xmlns:a16="http://schemas.microsoft.com/office/drawing/2014/main" id="{1ADF5CBA-955A-4388-8A1D-2F77EF1022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="" xmlns:a16="http://schemas.microsoft.com/office/drawing/2014/main" id="{A8353B72-DD39-4135-B010-63E96B7F82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="" xmlns:a16="http://schemas.microsoft.com/office/drawing/2014/main" id="{C153C7B3-D750-4AD9-85D2-097D0A340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18104-7529-4603-8183-3844D4C38BF7}" type="datetimeFigureOut">
              <a:rPr lang="fr-FR" smtClean="0"/>
              <a:t>16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="" xmlns:a16="http://schemas.microsoft.com/office/drawing/2014/main" id="{8CCBDB3A-1F4B-4912-8776-E65A16385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="" xmlns:a16="http://schemas.microsoft.com/office/drawing/2014/main" id="{0B05613C-0B78-4D5A-AD73-B42EFE315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432D6-3426-44AA-A865-C115F9DCCA9A}" type="slidenum">
              <a:rPr lang="fr-FR" smtClean="0"/>
              <a:t>‹N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1076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="" xmlns:a16="http://schemas.microsoft.com/office/drawing/2014/main" id="{BDF14E88-1653-4701-8F83-9C7F390D60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="" xmlns:a16="http://schemas.microsoft.com/office/drawing/2014/main" id="{0BA33CC6-6320-49EB-996E-167D919C18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="" xmlns:a16="http://schemas.microsoft.com/office/drawing/2014/main" id="{82460474-8FD5-4799-9C36-76C548E9FA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818104-7529-4603-8183-3844D4C38BF7}" type="datetimeFigureOut">
              <a:rPr lang="fr-FR" smtClean="0"/>
              <a:t>16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="" xmlns:a16="http://schemas.microsoft.com/office/drawing/2014/main" id="{D0C12957-734F-4008-A6C8-23F1C1B5F5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="" xmlns:a16="http://schemas.microsoft.com/office/drawing/2014/main" id="{A35A3961-2721-4261-AFB4-018850F598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8432D6-3426-44AA-A865-C115F9DCCA9A}" type="slidenum">
              <a:rPr lang="fr-FR" smtClean="0"/>
              <a:t>‹N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9507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23325" y="3460128"/>
            <a:ext cx="4003904" cy="3002928"/>
          </a:xfrm>
          <a:prstGeom prst="rect">
            <a:avLst/>
          </a:prstGeom>
        </p:spPr>
      </p:pic>
      <p:pic>
        <p:nvPicPr>
          <p:cNvPr id="12" name="Immagine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2746" y="3460128"/>
            <a:ext cx="4003904" cy="3002928"/>
          </a:xfrm>
          <a:prstGeom prst="rect">
            <a:avLst/>
          </a:prstGeom>
        </p:spPr>
      </p:pic>
      <p:pic>
        <p:nvPicPr>
          <p:cNvPr id="13" name="Immagine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27790" y="371475"/>
            <a:ext cx="4003904" cy="3002928"/>
          </a:xfrm>
          <a:prstGeom prst="rect">
            <a:avLst/>
          </a:prstGeom>
        </p:spPr>
      </p:pic>
      <p:pic>
        <p:nvPicPr>
          <p:cNvPr id="14" name="Immagine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7211" y="371475"/>
            <a:ext cx="4003904" cy="3002928"/>
          </a:xfrm>
          <a:prstGeom prst="rect">
            <a:avLst/>
          </a:prstGeom>
        </p:spPr>
      </p:pic>
      <p:sp>
        <p:nvSpPr>
          <p:cNvPr id="8" name="CasellaDiTesto 7"/>
          <p:cNvSpPr txBox="1"/>
          <p:nvPr/>
        </p:nvSpPr>
        <p:spPr>
          <a:xfrm>
            <a:off x="150498" y="285750"/>
            <a:ext cx="1091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</a:t>
            </a:r>
            <a:r>
              <a:rPr lang="en-US" b="1" dirty="0" smtClean="0"/>
              <a:t>1G</a:t>
            </a:r>
            <a:endParaRPr lang="en-US" b="1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5585225" y="388382"/>
            <a:ext cx="11801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>
                <a:solidFill>
                  <a:schemeClr val="bg1"/>
                </a:solidFill>
              </a:rPr>
              <a:t>shTFR</a:t>
            </a:r>
            <a:r>
              <a:rPr lang="en-US" dirty="0" smtClean="0">
                <a:solidFill>
                  <a:schemeClr val="bg1"/>
                </a:solidFill>
              </a:rPr>
              <a:t>-GFP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5585225" y="3548178"/>
            <a:ext cx="666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WGA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1651400" y="3548178"/>
            <a:ext cx="6333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DAPI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1656826" y="388382"/>
            <a:ext cx="9185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Merged</a:t>
            </a:r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647921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Segnaposto contenuto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3049" y="466171"/>
            <a:ext cx="3986574" cy="2989931"/>
          </a:xfr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8339" y="3490954"/>
            <a:ext cx="3980914" cy="2985686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3836" y="3490954"/>
            <a:ext cx="3980914" cy="2985686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3835" y="470416"/>
            <a:ext cx="3980914" cy="2985686"/>
          </a:xfrm>
          <a:prstGeom prst="rect">
            <a:avLst/>
          </a:prstGeom>
        </p:spPr>
      </p:pic>
      <p:sp>
        <p:nvSpPr>
          <p:cNvPr id="8" name="CasellaDiTesto 7"/>
          <p:cNvSpPr txBox="1"/>
          <p:nvPr/>
        </p:nvSpPr>
        <p:spPr>
          <a:xfrm>
            <a:off x="150498" y="285750"/>
            <a:ext cx="1089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1H</a:t>
            </a:r>
            <a:endParaRPr lang="en-US" b="1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5553836" y="563289"/>
            <a:ext cx="1158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TFR-</a:t>
            </a:r>
            <a:r>
              <a:rPr lang="en-US" dirty="0" err="1" smtClean="0">
                <a:solidFill>
                  <a:schemeClr val="bg1"/>
                </a:solidFill>
              </a:rPr>
              <a:t>pHuji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5553836" y="3608785"/>
            <a:ext cx="7059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WGA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1591436" y="3608785"/>
            <a:ext cx="6710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DAPI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1596862" y="563289"/>
            <a:ext cx="9732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bg1"/>
                </a:solidFill>
              </a:rPr>
              <a:t>Merged</a:t>
            </a:r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855822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que 4">
            <a:extLst>
              <a:ext uri="{FF2B5EF4-FFF2-40B4-BE49-F238E27FC236}">
                <a16:creationId xmlns="" xmlns:a16="http://schemas.microsoft.com/office/drawing/2014/main" id="{FEA14BB3-ED2F-4842-B940-60CE5AA9CF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=""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 rot="16200000">
            <a:off x="5745203" y="85966"/>
            <a:ext cx="3894639" cy="5270591"/>
          </a:xfrm>
          <a:prstGeom prst="rect">
            <a:avLst/>
          </a:prstGeom>
        </p:spPr>
      </p:pic>
      <p:pic>
        <p:nvPicPr>
          <p:cNvPr id="13" name="Image 12" descr="Une image contenant texte&#10;&#10;Description générée automatiquement">
            <a:extLst>
              <a:ext uri="{FF2B5EF4-FFF2-40B4-BE49-F238E27FC236}">
                <a16:creationId xmlns="" xmlns:a16="http://schemas.microsoft.com/office/drawing/2014/main" id="{F835043A-FBDA-4BD4-A789-7698BE961BC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498" y="773942"/>
            <a:ext cx="5195328" cy="3894638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="" xmlns:a16="http://schemas.microsoft.com/office/drawing/2014/main" id="{723C2CA2-8B4C-4424-9151-6D7241B9C017}"/>
              </a:ext>
            </a:extLst>
          </p:cNvPr>
          <p:cNvSpPr txBox="1"/>
          <p:nvPr/>
        </p:nvSpPr>
        <p:spPr>
          <a:xfrm>
            <a:off x="1326944" y="589274"/>
            <a:ext cx="2770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hCTR</a:t>
            </a:r>
            <a:endParaRPr lang="fr-FR" dirty="0"/>
          </a:p>
        </p:txBody>
      </p:sp>
      <p:sp>
        <p:nvSpPr>
          <p:cNvPr id="6" name="ZoneTexte 5">
            <a:extLst>
              <a:ext uri="{FF2B5EF4-FFF2-40B4-BE49-F238E27FC236}">
                <a16:creationId xmlns="" xmlns:a16="http://schemas.microsoft.com/office/drawing/2014/main" id="{819098E3-0006-4B82-85ED-A5F5BEA5C7D1}"/>
              </a:ext>
            </a:extLst>
          </p:cNvPr>
          <p:cNvSpPr txBox="1"/>
          <p:nvPr/>
        </p:nvSpPr>
        <p:spPr>
          <a:xfrm>
            <a:off x="6289973" y="589274"/>
            <a:ext cx="2770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hDFO</a:t>
            </a:r>
            <a:endParaRPr lang="fr-FR" dirty="0"/>
          </a:p>
        </p:txBody>
      </p:sp>
      <p:sp>
        <p:nvSpPr>
          <p:cNvPr id="3" name="CasellaDiTesto 2"/>
          <p:cNvSpPr txBox="1"/>
          <p:nvPr/>
        </p:nvSpPr>
        <p:spPr>
          <a:xfrm>
            <a:off x="150498" y="285750"/>
            <a:ext cx="10413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1L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339309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16</Words>
  <Application>Microsoft Office PowerPoint</Application>
  <PresentationFormat>Personalizzato</PresentationFormat>
  <Paragraphs>13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4" baseType="lpstr">
      <vt:lpstr>Thème Office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lisabeth Jeanne Marie Thérèse Wyart</dc:creator>
  <cp:lastModifiedBy>MH</cp:lastModifiedBy>
  <cp:revision>9</cp:revision>
  <dcterms:created xsi:type="dcterms:W3CDTF">2021-12-15T18:09:10Z</dcterms:created>
  <dcterms:modified xsi:type="dcterms:W3CDTF">2021-12-16T16:31:47Z</dcterms:modified>
</cp:coreProperties>
</file>